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2" r:id="rId3"/>
    <p:sldId id="265" r:id="rId4"/>
    <p:sldId id="264" r:id="rId5"/>
    <p:sldId id="267" r:id="rId6"/>
    <p:sldId id="268" r:id="rId7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-696" y="-5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2A144230-BF9F-4E5B-8BD1-E57E1F99F7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0D520E3F-692F-4E40-B40B-E478CCF92E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5DFCBB9C-678C-4866-A0F4-611DCE4CF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A13A2EB5-7CB4-43E5-B72F-6394C1211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E2832CB0-4AEB-463B-B499-6019BD09E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33303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B9E32DD6-F596-432B-A8F7-F2236002B1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33AEA379-C41C-4603-BDD1-2D6FF99007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43FBD6A7-11FC-4511-BB7C-099ABDFEE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297F9BE0-7EFE-44A2-8855-82EA66EB6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8BC3FB73-B549-44CD-B8DA-FBE27518D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4000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B78D2FFB-E1A7-42DD-AAB8-CAFC4C37FD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C5C26644-5026-430F-8DCC-214A3C74C5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37BE5894-7C00-4472-871C-1FBC2F451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9D7D4ABA-A0C8-4750-9626-B1ADBD1841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8B8AEDAE-C002-4824-B9A1-0F76C6CCE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1079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D97D4F3E-9A0B-4CF1-97C6-FE2C841F51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17DC032C-DCAC-4A30-AE67-822F3A2097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46166CD3-BB09-4557-98B2-3D7076E80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6A9BF044-6897-4A22-9917-5213D459A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A1AC0851-DEBD-4F1B-8B88-618E6518D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8969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ACE09992-6381-4578-B4CC-42F76E405B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C27AFB66-571A-4C5C-BABA-78F13AF0C3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5BC471DC-2FC8-42B4-8300-C6F6A99AA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E886BD60-7A36-48D3-8CCF-4F88295DB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60E08D16-0A68-4A4B-AA90-A3162D264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0858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621A0F4C-78D1-4584-B18E-2CD6033904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1C58FA98-C429-45D5-B7BF-3EB7ED0FCA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1341FEC7-AD2C-4627-A79C-E67D32A7CA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D8A8A2A0-556D-4714-9FFD-B175CFAB5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B9BFD7C9-52A2-4D38-88A0-6A4977E3A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1DB2B1EB-5828-46F7-8858-554B3FD7D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343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0B0A15EF-4431-45BB-8E11-100DDF4095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5F84B149-C577-46E0-BC48-9B5037BA61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009E84F0-D34C-4E28-8F2C-6183137EFE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xmlns="" id="{2F690ED0-6C2C-438B-BF9F-7FC97EF172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xmlns="" id="{F15E10C2-7A5E-4D4D-BA7B-A5B63B8F71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xmlns="" id="{79BC421A-C4DF-4006-9686-FA25DFB55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xmlns="" id="{54283F18-3514-45FB-8651-4FAA58027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xmlns="" id="{97AE5B01-C2AB-451E-A319-9AB8132F0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9093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8C36A0E3-E483-48E5-A59A-6D69F3EE65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xmlns="" id="{58A2323D-3DA9-48ED-A754-62B10A26F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xmlns="" id="{A551E234-0CCB-4622-AB14-ADFDBAB94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xmlns="" id="{4E51F15C-F552-44DD-84D5-72AD4ED1E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161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xmlns="" id="{70C4A339-13FD-445D-98ED-FB3D7D745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xmlns="" id="{3FE3FD81-2E1D-4735-86F7-0FB027FA2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xmlns="" id="{BD26835F-CEC5-45DA-A2D0-ADA214763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4852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9D9D7A89-938E-4A40-B8E7-4CC07B8D93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AEC83D44-E9E0-4F8F-A531-303D49ACC8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3D0460F9-A42D-41FD-A296-77890C3309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3C792C3E-ACA7-403D-B7F9-947D87AB3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213065F1-C2D6-429D-BC87-D94F7BF9F5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26334684-AB6C-4AAB-8304-3561D3636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0092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0E7FAE6F-4214-4107-916E-FCB4355877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xmlns="" id="{5C7BC4F1-FBCB-4805-B5CB-08D9C3CF35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DD3CE5E0-F3E8-493E-94D9-C7C7F32421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745A4B1D-F690-4318-889A-EBDDA4DB5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C2945599-A4FC-445A-9222-7236F877C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31C5C025-36EF-4E2C-8E08-24891D721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2139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xmlns="" id="{0BB8B02D-A1CB-4335-BF99-478CED38C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FCCB3971-8C79-48BD-B95E-758C1CDDA5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87E399C0-471F-479D-A029-871550A688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9A4F07-6413-4683-B793-CB569182D96B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30D41480-B884-4C98-B86B-CDA5CFA6E7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56BFE33C-0933-462F-915D-02E316D47B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08FAF-9909-4B49-A49A-311C78820F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5647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xmlns="" id="{2F12E867-4764-457A-B04E-12B2C386BC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2603500"/>
          </a:xfrm>
        </p:spPr>
        <p:txBody>
          <a:bodyPr/>
          <a:lstStyle/>
          <a:p>
            <a:pPr marL="0" indent="0" algn="ctr">
              <a:buNone/>
            </a:pPr>
            <a:r>
              <a:rPr lang="en-US" b="1" dirty="0" err="1"/>
              <a:t>Fernández-Melero</a:t>
            </a:r>
            <a:r>
              <a:rPr lang="en-US" b="1" dirty="0"/>
              <a:t> et al</a:t>
            </a:r>
            <a:r>
              <a:rPr lang="en-US" b="1" dirty="0" smtClean="0"/>
              <a:t>. </a:t>
            </a:r>
            <a:r>
              <a:rPr lang="en-GB" b="1" dirty="0" smtClean="0"/>
              <a:t>Figure S5. </a:t>
            </a:r>
            <a:r>
              <a:rPr lang="en-GB" b="1" dirty="0"/>
              <a:t>Sequence alignments of the cloned </a:t>
            </a:r>
            <a:r>
              <a:rPr lang="en-GB" b="1" dirty="0" smtClean="0"/>
              <a:t>RLK </a:t>
            </a:r>
            <a:r>
              <a:rPr lang="en-GB" b="1" dirty="0" err="1" smtClean="0"/>
              <a:t>cDNAs</a:t>
            </a:r>
            <a:r>
              <a:rPr lang="en-GB" b="1" dirty="0" smtClean="0"/>
              <a:t> </a:t>
            </a:r>
            <a:r>
              <a:rPr lang="en-GB" b="1" dirty="0"/>
              <a:t>from B117 and </a:t>
            </a:r>
            <a:r>
              <a:rPr lang="en-GB" b="1" dirty="0" smtClean="0"/>
              <a:t>DEB2</a:t>
            </a:r>
            <a:r>
              <a:rPr lang="en-GB" dirty="0" smtClean="0"/>
              <a:t>. </a:t>
            </a:r>
            <a:r>
              <a:rPr lang="en-GB" b="1" dirty="0"/>
              <a:t>(A)</a:t>
            </a:r>
            <a:r>
              <a:rPr lang="en-GB" dirty="0"/>
              <a:t> Alignment of the reference sequences with their corresponding cloned cDNA sequences, illustrating overall sequence conservation and </a:t>
            </a:r>
            <a:r>
              <a:rPr lang="en-GB" dirty="0" smtClean="0"/>
              <a:t>exon-intron </a:t>
            </a:r>
            <a:r>
              <a:rPr lang="en-GB" dirty="0"/>
              <a:t>structure. </a:t>
            </a:r>
            <a:r>
              <a:rPr lang="en-GB" b="1" dirty="0"/>
              <a:t>(B)</a:t>
            </a:r>
            <a:r>
              <a:rPr lang="en-GB" dirty="0"/>
              <a:t> Nucleotide alignments at higher resolution, highlighting the correspondence between the nucleotides of each sequence. </a:t>
            </a:r>
          </a:p>
        </p:txBody>
      </p:sp>
    </p:spTree>
    <p:extLst>
      <p:ext uri="{BB962C8B-B14F-4D97-AF65-F5344CB8AC3E}">
        <p14:creationId xmlns:p14="http://schemas.microsoft.com/office/powerpoint/2010/main" val="22585278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2 Grupo"/>
          <p:cNvGrpSpPr/>
          <p:nvPr/>
        </p:nvGrpSpPr>
        <p:grpSpPr>
          <a:xfrm>
            <a:off x="213360" y="174689"/>
            <a:ext cx="10484000" cy="6525337"/>
            <a:chOff x="213360" y="174689"/>
            <a:chExt cx="10484000" cy="6525337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FBAEEF04-C60C-49D0-AAF0-D837ADC27298}"/>
                </a:ext>
              </a:extLst>
            </p:cNvPr>
            <p:cNvSpPr txBox="1"/>
            <p:nvPr/>
          </p:nvSpPr>
          <p:spPr>
            <a:xfrm>
              <a:off x="213360" y="174689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A)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B88AD659-994F-48AF-B753-9823A4CA61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29"/>
            <a:stretch/>
          </p:blipFill>
          <p:spPr>
            <a:xfrm>
              <a:off x="3515291" y="5156976"/>
              <a:ext cx="7182069" cy="1543050"/>
            </a:xfrm>
            <a:prstGeom prst="rect">
              <a:avLst/>
            </a:prstGeom>
          </p:spPr>
        </p:pic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xmlns="" id="{1E431969-3AE3-4800-9B42-DA70BA9E74CD}"/>
                </a:ext>
              </a:extLst>
            </p:cNvPr>
            <p:cNvGrpSpPr/>
            <p:nvPr/>
          </p:nvGrpSpPr>
          <p:grpSpPr>
            <a:xfrm>
              <a:off x="748145" y="261465"/>
              <a:ext cx="9854883" cy="6319316"/>
              <a:chOff x="748145" y="261465"/>
              <a:chExt cx="9854883" cy="6319316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xmlns="" id="{61AEFB54-48E3-48CF-8403-B4B80DF2DA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06903" y="1767422"/>
                <a:ext cx="7096125" cy="154305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xmlns="" id="{E61BDDB2-A43B-46A0-BC4A-20BFA57FF7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07675" y="261465"/>
                <a:ext cx="7077075" cy="1543050"/>
              </a:xfrm>
              <a:prstGeom prst="rect">
                <a:avLst/>
              </a:prstGeom>
            </p:spPr>
          </p:pic>
          <p:sp>
            <p:nvSpPr>
              <p:cNvPr id="21" name="Rectángulo 20">
                <a:extLst>
                  <a:ext uri="{FF2B5EF4-FFF2-40B4-BE49-F238E27FC236}">
                    <a16:creationId xmlns:a16="http://schemas.microsoft.com/office/drawing/2014/main" xmlns="" id="{CB620C9F-E422-49B6-81DE-21ACFC7D9CC6}"/>
                  </a:ext>
                </a:extLst>
              </p:cNvPr>
              <p:cNvSpPr/>
              <p:nvPr/>
            </p:nvSpPr>
            <p:spPr>
              <a:xfrm>
                <a:off x="748145" y="694985"/>
                <a:ext cx="4133899" cy="76944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i="1" dirty="0" smtClean="0"/>
                  <a:t>HannDeb2Chr04g005720 </a:t>
                </a:r>
                <a:r>
                  <a:rPr lang="en-US" sz="1400" dirty="0" smtClean="0"/>
                  <a:t>(</a:t>
                </a:r>
                <a:r>
                  <a:rPr lang="en-US" sz="1400" i="1" dirty="0" smtClean="0"/>
                  <a:t>RLK-2</a:t>
                </a:r>
                <a:r>
                  <a:rPr lang="en-US" sz="1400" dirty="0" smtClean="0"/>
                  <a:t>)-genomic reference</a:t>
                </a:r>
                <a:endParaRPr lang="en-US" sz="1400" dirty="0"/>
              </a:p>
              <a:p>
                <a:pPr algn="r"/>
                <a:endParaRPr lang="en-US" sz="1600" dirty="0"/>
              </a:p>
              <a:p>
                <a:pPr algn="r"/>
                <a:r>
                  <a:rPr lang="en-US" sz="1400" dirty="0"/>
                  <a:t>Cloned cDNA </a:t>
                </a:r>
                <a:r>
                  <a:rPr lang="en-US" sz="1400" i="1" dirty="0" smtClean="0"/>
                  <a:t>RLK-2</a:t>
                </a:r>
                <a:endParaRPr lang="en-US" sz="1400" i="1" dirty="0"/>
              </a:p>
            </p:txBody>
          </p:sp>
          <p:sp>
            <p:nvSpPr>
              <p:cNvPr id="28" name="Rectángulo 27">
                <a:extLst>
                  <a:ext uri="{FF2B5EF4-FFF2-40B4-BE49-F238E27FC236}">
                    <a16:creationId xmlns:a16="http://schemas.microsoft.com/office/drawing/2014/main" xmlns="" id="{08A23044-7283-4970-BC03-FACEAA0DC8F5}"/>
                  </a:ext>
                </a:extLst>
              </p:cNvPr>
              <p:cNvSpPr/>
              <p:nvPr/>
            </p:nvSpPr>
            <p:spPr>
              <a:xfrm>
                <a:off x="748145" y="2202879"/>
                <a:ext cx="4187229" cy="84638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i="1" dirty="0" smtClean="0"/>
                  <a:t>HannDeb2Chr04g005880 </a:t>
                </a:r>
                <a:r>
                  <a:rPr lang="en-US" sz="1400" dirty="0" smtClean="0"/>
                  <a:t>(</a:t>
                </a:r>
                <a:r>
                  <a:rPr lang="en-US" sz="1400" i="1" dirty="0" smtClean="0"/>
                  <a:t>RLK-4</a:t>
                </a:r>
                <a:r>
                  <a:rPr lang="en-US" sz="1400" dirty="0" smtClean="0"/>
                  <a:t>)-genomic reference</a:t>
                </a:r>
              </a:p>
              <a:p>
                <a:pPr algn="r"/>
                <a:endParaRPr lang="en-US" sz="1600" dirty="0" smtClean="0"/>
              </a:p>
              <a:p>
                <a:pPr algn="r"/>
                <a:r>
                  <a:rPr lang="en-US" sz="1400" dirty="0" smtClean="0"/>
                  <a:t>Cloned </a:t>
                </a:r>
                <a:r>
                  <a:rPr lang="en-US" sz="1400" dirty="0"/>
                  <a:t>cDNA </a:t>
                </a:r>
                <a:r>
                  <a:rPr lang="en-US" sz="1400" i="1" dirty="0" smtClean="0"/>
                  <a:t>RLK-4</a:t>
                </a:r>
                <a:endParaRPr lang="en-US" sz="1400" i="1" dirty="0"/>
              </a:p>
            </p:txBody>
          </p:sp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xmlns="" id="{79A315BF-106E-442D-8DFC-4A2AF9D7510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07"/>
              <a:stretch/>
            </p:blipFill>
            <p:spPr>
              <a:xfrm>
                <a:off x="3506902" y="3367396"/>
                <a:ext cx="7096126" cy="1639558"/>
              </a:xfrm>
              <a:prstGeom prst="rect">
                <a:avLst/>
              </a:prstGeom>
            </p:spPr>
          </p:pic>
          <p:sp>
            <p:nvSpPr>
              <p:cNvPr id="20" name="Rectángulo 27">
                <a:extLst>
                  <a:ext uri="{FF2B5EF4-FFF2-40B4-BE49-F238E27FC236}">
                    <a16:creationId xmlns:a16="http://schemas.microsoft.com/office/drawing/2014/main" xmlns="" id="{8C10D1B4-D32E-4DC6-98CA-3E7BAA71FBA2}"/>
                  </a:ext>
                </a:extLst>
              </p:cNvPr>
              <p:cNvSpPr/>
              <p:nvPr/>
            </p:nvSpPr>
            <p:spPr>
              <a:xfrm>
                <a:off x="2147582" y="5595896"/>
                <a:ext cx="2804569" cy="98488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i="1" dirty="0"/>
                  <a:t>B117Chr04_003660</a:t>
                </a:r>
              </a:p>
              <a:p>
                <a:pPr algn="r"/>
                <a:endParaRPr lang="en-US" sz="1600" dirty="0"/>
              </a:p>
              <a:p>
                <a:pPr algn="r"/>
                <a:r>
                  <a:rPr lang="en-US" sz="1400" dirty="0"/>
                  <a:t>Cloned cDNA </a:t>
                </a:r>
                <a:r>
                  <a:rPr lang="en-US" sz="1400" i="1" dirty="0"/>
                  <a:t>B117Chr04_003660</a:t>
                </a:r>
              </a:p>
              <a:p>
                <a:pPr algn="r"/>
                <a:endParaRPr lang="en-US" sz="1400" dirty="0"/>
              </a:p>
            </p:txBody>
          </p:sp>
          <p:sp>
            <p:nvSpPr>
              <p:cNvPr id="23" name="Rectángulo 27">
                <a:extLst>
                  <a:ext uri="{FF2B5EF4-FFF2-40B4-BE49-F238E27FC236}">
                    <a16:creationId xmlns:a16="http://schemas.microsoft.com/office/drawing/2014/main" xmlns="" id="{33EC70F8-142E-4EEA-B296-43699A57C2C1}"/>
                  </a:ext>
                </a:extLst>
              </p:cNvPr>
              <p:cNvSpPr/>
              <p:nvPr/>
            </p:nvSpPr>
            <p:spPr>
              <a:xfrm>
                <a:off x="1937857" y="3847547"/>
                <a:ext cx="2994521" cy="98488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i="1" dirty="0"/>
                  <a:t>B117Chr04_003667</a:t>
                </a:r>
              </a:p>
              <a:p>
                <a:pPr algn="r"/>
                <a:endParaRPr lang="en-US" sz="1600" dirty="0"/>
              </a:p>
              <a:p>
                <a:pPr algn="r"/>
                <a:r>
                  <a:rPr lang="en-US" sz="1400" dirty="0"/>
                  <a:t>Cloned cDNA </a:t>
                </a:r>
                <a:r>
                  <a:rPr lang="en-US" sz="1400" i="1" dirty="0"/>
                  <a:t>B117Chr04_003667</a:t>
                </a:r>
              </a:p>
              <a:p>
                <a:pPr algn="r"/>
                <a:endParaRPr lang="en-US" sz="1400" dirty="0"/>
              </a:p>
            </p:txBody>
          </p:sp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xmlns="" id="{0C58B45B-9D39-4F67-B848-40E62CBB1A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286" r="87351" b="81336"/>
              <a:stretch/>
            </p:blipFill>
            <p:spPr>
              <a:xfrm>
                <a:off x="3374850" y="3431106"/>
                <a:ext cx="895147" cy="252714"/>
              </a:xfrm>
              <a:prstGeom prst="rect">
                <a:avLst/>
              </a:prstGeom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xmlns="" id="{1BD95387-2CF9-48A1-A68C-F45C9C74FF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286" r="87351" b="81336"/>
              <a:stretch/>
            </p:blipFill>
            <p:spPr>
              <a:xfrm>
                <a:off x="3374849" y="5255390"/>
                <a:ext cx="895147" cy="252714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969757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61AE6265-3485-4453-A16C-612CD1EEAFD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36"/>
          <a:stretch/>
        </p:blipFill>
        <p:spPr>
          <a:xfrm>
            <a:off x="268653" y="1177423"/>
            <a:ext cx="5756519" cy="450131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638BFD7F-2EE8-4B4D-9858-FC3A77CD78E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96"/>
          <a:stretch/>
        </p:blipFill>
        <p:spPr>
          <a:xfrm>
            <a:off x="6348411" y="1177423"/>
            <a:ext cx="5752671" cy="4501313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6D4E988C-5200-4B9D-A7C4-D1CECA3703DB}"/>
              </a:ext>
            </a:extLst>
          </p:cNvPr>
          <p:cNvSpPr txBox="1"/>
          <p:nvPr/>
        </p:nvSpPr>
        <p:spPr>
          <a:xfrm>
            <a:off x="-76149" y="117742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xmlns="" id="{82D5E0D5-EDBA-4DC4-BB2C-26BBE7A5E30B}"/>
              </a:ext>
            </a:extLst>
          </p:cNvPr>
          <p:cNvSpPr txBox="1"/>
          <p:nvPr/>
        </p:nvSpPr>
        <p:spPr>
          <a:xfrm>
            <a:off x="-76149" y="1691717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F6E55658-5022-4EF9-8AC1-CC8BB9F325C5}"/>
              </a:ext>
            </a:extLst>
          </p:cNvPr>
          <p:cNvSpPr txBox="1"/>
          <p:nvPr/>
        </p:nvSpPr>
        <p:spPr>
          <a:xfrm>
            <a:off x="-76149" y="221553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E65C4B9F-9249-419F-867F-79C1D7CDC092}"/>
              </a:ext>
            </a:extLst>
          </p:cNvPr>
          <p:cNvSpPr txBox="1"/>
          <p:nvPr/>
        </p:nvSpPr>
        <p:spPr>
          <a:xfrm>
            <a:off x="-76149" y="2729828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xmlns="" id="{28CAEBA1-19E1-45F4-AFC5-770A56FE2BB8}"/>
              </a:ext>
            </a:extLst>
          </p:cNvPr>
          <p:cNvSpPr txBox="1"/>
          <p:nvPr/>
        </p:nvSpPr>
        <p:spPr>
          <a:xfrm>
            <a:off x="-76149" y="3254643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019D577D-1A6A-45C2-95FA-EE386277E808}"/>
              </a:ext>
            </a:extLst>
          </p:cNvPr>
          <p:cNvSpPr txBox="1"/>
          <p:nvPr/>
        </p:nvSpPr>
        <p:spPr>
          <a:xfrm>
            <a:off x="-76149" y="3768936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1EE2FE6F-9931-4BAC-A2B2-E0888079C56E}"/>
              </a:ext>
            </a:extLst>
          </p:cNvPr>
          <p:cNvSpPr txBox="1"/>
          <p:nvPr/>
        </p:nvSpPr>
        <p:spPr>
          <a:xfrm>
            <a:off x="-76149" y="429275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xmlns="" id="{66ED51EF-4306-4D66-9FAE-D1359048FCDE}"/>
              </a:ext>
            </a:extLst>
          </p:cNvPr>
          <p:cNvSpPr txBox="1"/>
          <p:nvPr/>
        </p:nvSpPr>
        <p:spPr>
          <a:xfrm>
            <a:off x="-76149" y="4807047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xmlns="" id="{F7BE0903-7F30-4E08-8C91-8F97403D0D94}"/>
              </a:ext>
            </a:extLst>
          </p:cNvPr>
          <p:cNvSpPr txBox="1"/>
          <p:nvPr/>
        </p:nvSpPr>
        <p:spPr>
          <a:xfrm>
            <a:off x="-76149" y="5327690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xmlns="" id="{E4BF4AF1-3AE1-43C0-BF67-09B28E05AF7C}"/>
              </a:ext>
            </a:extLst>
          </p:cNvPr>
          <p:cNvSpPr txBox="1"/>
          <p:nvPr/>
        </p:nvSpPr>
        <p:spPr>
          <a:xfrm>
            <a:off x="5998093" y="1179263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xmlns="" id="{3F131D8D-D9C9-47B1-943A-DD03F48D6952}"/>
              </a:ext>
            </a:extLst>
          </p:cNvPr>
          <p:cNvSpPr txBox="1"/>
          <p:nvPr/>
        </p:nvSpPr>
        <p:spPr>
          <a:xfrm>
            <a:off x="5998093" y="1693556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xmlns="" id="{75C84918-4667-4594-8E41-C6BD9436D35E}"/>
              </a:ext>
            </a:extLst>
          </p:cNvPr>
          <p:cNvSpPr txBox="1"/>
          <p:nvPr/>
        </p:nvSpPr>
        <p:spPr>
          <a:xfrm>
            <a:off x="5998093" y="221737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942FDDD1-44D7-47A5-B6D6-688BBCC4211C}"/>
              </a:ext>
            </a:extLst>
          </p:cNvPr>
          <p:cNvSpPr txBox="1"/>
          <p:nvPr/>
        </p:nvSpPr>
        <p:spPr>
          <a:xfrm>
            <a:off x="5998093" y="2731667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07C4CDF3-E746-46BF-956E-ED1F367E9CB5}"/>
              </a:ext>
            </a:extLst>
          </p:cNvPr>
          <p:cNvSpPr txBox="1"/>
          <p:nvPr/>
        </p:nvSpPr>
        <p:spPr>
          <a:xfrm>
            <a:off x="5998093" y="3256482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xmlns="" id="{65439A9E-89FB-48F3-AD6A-F20EDFD60F9D}"/>
              </a:ext>
            </a:extLst>
          </p:cNvPr>
          <p:cNvSpPr txBox="1"/>
          <p:nvPr/>
        </p:nvSpPr>
        <p:spPr>
          <a:xfrm>
            <a:off x="5998093" y="377077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xmlns="" id="{AD93A7E0-D6BF-4D1D-8B71-513499AF92D8}"/>
              </a:ext>
            </a:extLst>
          </p:cNvPr>
          <p:cNvSpPr txBox="1"/>
          <p:nvPr/>
        </p:nvSpPr>
        <p:spPr>
          <a:xfrm>
            <a:off x="5998093" y="4294593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xmlns="" id="{E2D4614D-6F7D-46D4-B730-554A2D305A83}"/>
              </a:ext>
            </a:extLst>
          </p:cNvPr>
          <p:cNvSpPr txBox="1"/>
          <p:nvPr/>
        </p:nvSpPr>
        <p:spPr>
          <a:xfrm>
            <a:off x="5998093" y="4808886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xmlns="" id="{D1E13DCD-B56B-4119-9047-AA1A698D6E76}"/>
              </a:ext>
            </a:extLst>
          </p:cNvPr>
          <p:cNvSpPr txBox="1"/>
          <p:nvPr/>
        </p:nvSpPr>
        <p:spPr>
          <a:xfrm>
            <a:off x="5998093" y="5329529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6" name="Título 1">
            <a:extLst>
              <a:ext uri="{FF2B5EF4-FFF2-40B4-BE49-F238E27FC236}">
                <a16:creationId xmlns:a16="http://schemas.microsoft.com/office/drawing/2014/main" xmlns="" id="{6BCCDEBB-DE28-42E9-87FB-8BCE08E9BE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917" y="482318"/>
            <a:ext cx="10515600" cy="274955"/>
          </a:xfrm>
        </p:spPr>
        <p:txBody>
          <a:bodyPr>
            <a:noAutofit/>
          </a:bodyPr>
          <a:lstStyle/>
          <a:p>
            <a:pPr algn="ctr"/>
            <a:r>
              <a:rPr lang="en-US" sz="2000" b="1" i="1" dirty="0"/>
              <a:t>HannDeb2Chr04g005720</a:t>
            </a:r>
            <a:r>
              <a:rPr lang="en-US" sz="2000" b="1" dirty="0"/>
              <a:t> (</a:t>
            </a:r>
            <a:r>
              <a:rPr lang="en-US" sz="2000" b="1" i="1" dirty="0" smtClean="0"/>
              <a:t>RLK-2</a:t>
            </a:r>
            <a:r>
              <a:rPr lang="en-US" sz="2000" b="1" dirty="0"/>
              <a:t>)</a:t>
            </a:r>
          </a:p>
        </p:txBody>
      </p:sp>
      <p:sp>
        <p:nvSpPr>
          <p:cNvPr id="27" name="TextBox 1">
            <a:extLst>
              <a:ext uri="{FF2B5EF4-FFF2-40B4-BE49-F238E27FC236}">
                <a16:creationId xmlns:a16="http://schemas.microsoft.com/office/drawing/2014/main" xmlns="" id="{FBAEEF04-C60C-49D0-AAF0-D837ADC27298}"/>
              </a:ext>
            </a:extLst>
          </p:cNvPr>
          <p:cNvSpPr txBox="1"/>
          <p:nvPr/>
        </p:nvSpPr>
        <p:spPr>
          <a:xfrm>
            <a:off x="213360" y="174689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)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4470498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072EC9A7-3FCB-4677-A53F-D41D8A31D23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3"/>
          <a:stretch/>
        </p:blipFill>
        <p:spPr>
          <a:xfrm>
            <a:off x="245280" y="945695"/>
            <a:ext cx="5846217" cy="455717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CEDA9C17-3045-4B55-9757-D4444142451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7"/>
          <a:stretch/>
        </p:blipFill>
        <p:spPr>
          <a:xfrm>
            <a:off x="6315822" y="962788"/>
            <a:ext cx="5846217" cy="4557169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80945E22-6392-4730-A204-F50A5F28705B}"/>
              </a:ext>
            </a:extLst>
          </p:cNvPr>
          <p:cNvSpPr txBox="1"/>
          <p:nvPr/>
        </p:nvSpPr>
        <p:spPr>
          <a:xfrm>
            <a:off x="-81377" y="98107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9" name="Título 1">
            <a:extLst>
              <a:ext uri="{FF2B5EF4-FFF2-40B4-BE49-F238E27FC236}">
                <a16:creationId xmlns:a16="http://schemas.microsoft.com/office/drawing/2014/main" xmlns="" id="{417A635D-E99E-48B4-ACD1-6F127FB93C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917" y="351693"/>
            <a:ext cx="10515600" cy="274955"/>
          </a:xfrm>
        </p:spPr>
        <p:txBody>
          <a:bodyPr>
            <a:noAutofit/>
          </a:bodyPr>
          <a:lstStyle/>
          <a:p>
            <a:pPr algn="ctr"/>
            <a:r>
              <a:rPr lang="en-US" sz="2000" b="1" i="1" dirty="0"/>
              <a:t>HannDeb2Chr04g005880</a:t>
            </a:r>
            <a:r>
              <a:rPr lang="en-US" sz="2000" b="1" dirty="0"/>
              <a:t> (</a:t>
            </a:r>
            <a:r>
              <a:rPr lang="en-US" sz="2000" b="1" i="1" dirty="0" smtClean="0"/>
              <a:t>RLK-4</a:t>
            </a:r>
            <a:r>
              <a:rPr lang="en-US" sz="2000" b="1" dirty="0"/>
              <a:t>)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B060A5CF-ACBE-4F33-B08C-D917A5B07148}"/>
              </a:ext>
            </a:extLst>
          </p:cNvPr>
          <p:cNvSpPr txBox="1"/>
          <p:nvPr/>
        </p:nvSpPr>
        <p:spPr>
          <a:xfrm>
            <a:off x="-81377" y="1495368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7AE839CB-116A-46CD-81D4-650762C404A9}"/>
              </a:ext>
            </a:extLst>
          </p:cNvPr>
          <p:cNvSpPr txBox="1"/>
          <p:nvPr/>
        </p:nvSpPr>
        <p:spPr>
          <a:xfrm>
            <a:off x="-81377" y="2019186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xmlns="" id="{0F41E53E-F993-4033-A0F5-94FBAE5D4E95}"/>
              </a:ext>
            </a:extLst>
          </p:cNvPr>
          <p:cNvSpPr txBox="1"/>
          <p:nvPr/>
        </p:nvSpPr>
        <p:spPr>
          <a:xfrm>
            <a:off x="-81377" y="2533479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5EBFCA43-96D9-43AC-A6AE-4CD8FCD5B7A1}"/>
              </a:ext>
            </a:extLst>
          </p:cNvPr>
          <p:cNvSpPr txBox="1"/>
          <p:nvPr/>
        </p:nvSpPr>
        <p:spPr>
          <a:xfrm>
            <a:off x="-81377" y="305829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46863CA6-6732-4C1D-92D6-9083F4DB2E0F}"/>
              </a:ext>
            </a:extLst>
          </p:cNvPr>
          <p:cNvSpPr txBox="1"/>
          <p:nvPr/>
        </p:nvSpPr>
        <p:spPr>
          <a:xfrm>
            <a:off x="-81377" y="3572587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xmlns="" id="{5C48185D-A4EF-48BB-B972-3AC1E28ED522}"/>
              </a:ext>
            </a:extLst>
          </p:cNvPr>
          <p:cNvSpPr txBox="1"/>
          <p:nvPr/>
        </p:nvSpPr>
        <p:spPr>
          <a:xfrm>
            <a:off x="-81377" y="409640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xmlns="" id="{FC7E10CC-4695-4195-B339-A744FCA7BF9C}"/>
              </a:ext>
            </a:extLst>
          </p:cNvPr>
          <p:cNvSpPr txBox="1"/>
          <p:nvPr/>
        </p:nvSpPr>
        <p:spPr>
          <a:xfrm>
            <a:off x="-81377" y="4610698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xmlns="" id="{36E35497-C38A-4EB8-B445-C1E7A65AEDAD}"/>
              </a:ext>
            </a:extLst>
          </p:cNvPr>
          <p:cNvSpPr txBox="1"/>
          <p:nvPr/>
        </p:nvSpPr>
        <p:spPr>
          <a:xfrm>
            <a:off x="-81377" y="5131341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xmlns="" id="{5342DC3B-28A2-4D76-A37F-6FE1BB708FAE}"/>
              </a:ext>
            </a:extLst>
          </p:cNvPr>
          <p:cNvSpPr txBox="1"/>
          <p:nvPr/>
        </p:nvSpPr>
        <p:spPr>
          <a:xfrm>
            <a:off x="5999979" y="988221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A168601C-C0AA-47F7-A1D8-76E0BB36B396}"/>
              </a:ext>
            </a:extLst>
          </p:cNvPr>
          <p:cNvSpPr txBox="1"/>
          <p:nvPr/>
        </p:nvSpPr>
        <p:spPr>
          <a:xfrm>
            <a:off x="5999979" y="150251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E4C4861C-796C-458A-9467-7350F4D5D63C}"/>
              </a:ext>
            </a:extLst>
          </p:cNvPr>
          <p:cNvSpPr txBox="1"/>
          <p:nvPr/>
        </p:nvSpPr>
        <p:spPr>
          <a:xfrm>
            <a:off x="5999979" y="2026332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xmlns="" id="{852CCE2F-4BBD-498E-A633-93257C79E3A2}"/>
              </a:ext>
            </a:extLst>
          </p:cNvPr>
          <p:cNvSpPr txBox="1"/>
          <p:nvPr/>
        </p:nvSpPr>
        <p:spPr>
          <a:xfrm>
            <a:off x="5999979" y="254062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xmlns="" id="{F7275B4A-EB14-4CB3-80C9-3CFE0C75182B}"/>
              </a:ext>
            </a:extLst>
          </p:cNvPr>
          <p:cNvSpPr txBox="1"/>
          <p:nvPr/>
        </p:nvSpPr>
        <p:spPr>
          <a:xfrm>
            <a:off x="5999979" y="3065440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xmlns="" id="{A49DE36A-3F8F-4033-A9B7-19AED97F859C}"/>
              </a:ext>
            </a:extLst>
          </p:cNvPr>
          <p:cNvSpPr txBox="1"/>
          <p:nvPr/>
        </p:nvSpPr>
        <p:spPr>
          <a:xfrm>
            <a:off x="5999979" y="3579733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xmlns="" id="{7CDBBCD7-DF52-484E-A73B-B37D2B47A011}"/>
              </a:ext>
            </a:extLst>
          </p:cNvPr>
          <p:cNvSpPr txBox="1"/>
          <p:nvPr/>
        </p:nvSpPr>
        <p:spPr>
          <a:xfrm>
            <a:off x="5999979" y="4103551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xmlns="" id="{5C387B35-2615-4080-B86D-1414AAA9DF16}"/>
              </a:ext>
            </a:extLst>
          </p:cNvPr>
          <p:cNvSpPr txBox="1"/>
          <p:nvPr/>
        </p:nvSpPr>
        <p:spPr>
          <a:xfrm>
            <a:off x="5999979" y="461784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xmlns="" id="{3B7EC26E-A454-47A7-82A9-1029AACE40EC}"/>
              </a:ext>
            </a:extLst>
          </p:cNvPr>
          <p:cNvSpPr txBox="1"/>
          <p:nvPr/>
        </p:nvSpPr>
        <p:spPr>
          <a:xfrm>
            <a:off x="5999979" y="5138487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</p:spTree>
    <p:extLst>
      <p:ext uri="{BB962C8B-B14F-4D97-AF65-F5344CB8AC3E}">
        <p14:creationId xmlns:p14="http://schemas.microsoft.com/office/powerpoint/2010/main" val="36661580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E3FD5136-BFA6-46BF-9D35-A628C031F4D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5"/>
          <a:stretch/>
        </p:blipFill>
        <p:spPr>
          <a:xfrm>
            <a:off x="200347" y="950602"/>
            <a:ext cx="5877929" cy="458818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6B4DBCAC-86E8-429D-8BCE-6D90D212260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5"/>
          <a:stretch/>
        </p:blipFill>
        <p:spPr>
          <a:xfrm>
            <a:off x="6303145" y="957741"/>
            <a:ext cx="5877929" cy="4588186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80945E22-6392-4730-A204-F50A5F28705B}"/>
              </a:ext>
            </a:extLst>
          </p:cNvPr>
          <p:cNvSpPr txBox="1"/>
          <p:nvPr/>
        </p:nvSpPr>
        <p:spPr>
          <a:xfrm>
            <a:off x="-129002" y="98107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9" name="Título 1">
            <a:extLst>
              <a:ext uri="{FF2B5EF4-FFF2-40B4-BE49-F238E27FC236}">
                <a16:creationId xmlns:a16="http://schemas.microsoft.com/office/drawing/2014/main" xmlns="" id="{417A635D-E99E-48B4-ACD1-6F127FB93C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917" y="351693"/>
            <a:ext cx="10515600" cy="274955"/>
          </a:xfrm>
        </p:spPr>
        <p:txBody>
          <a:bodyPr>
            <a:noAutofit/>
          </a:bodyPr>
          <a:lstStyle/>
          <a:p>
            <a:pPr algn="ctr"/>
            <a:r>
              <a:rPr lang="en-US" sz="2000" b="1" i="1" dirty="0" smtClean="0"/>
              <a:t>B117Chr04_g003667</a:t>
            </a:r>
            <a:endParaRPr lang="en-US" sz="2000" b="1" i="1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B060A5CF-ACBE-4F33-B08C-D917A5B07148}"/>
              </a:ext>
            </a:extLst>
          </p:cNvPr>
          <p:cNvSpPr txBox="1"/>
          <p:nvPr/>
        </p:nvSpPr>
        <p:spPr>
          <a:xfrm>
            <a:off x="-129002" y="1495368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7AE839CB-116A-46CD-81D4-650762C404A9}"/>
              </a:ext>
            </a:extLst>
          </p:cNvPr>
          <p:cNvSpPr txBox="1"/>
          <p:nvPr/>
        </p:nvSpPr>
        <p:spPr>
          <a:xfrm>
            <a:off x="-129002" y="2019186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xmlns="" id="{0F41E53E-F993-4033-A0F5-94FBAE5D4E95}"/>
              </a:ext>
            </a:extLst>
          </p:cNvPr>
          <p:cNvSpPr txBox="1"/>
          <p:nvPr/>
        </p:nvSpPr>
        <p:spPr>
          <a:xfrm>
            <a:off x="-129002" y="2533479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5EBFCA43-96D9-43AC-A6AE-4CD8FCD5B7A1}"/>
              </a:ext>
            </a:extLst>
          </p:cNvPr>
          <p:cNvSpPr txBox="1"/>
          <p:nvPr/>
        </p:nvSpPr>
        <p:spPr>
          <a:xfrm>
            <a:off x="-129002" y="305829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46863CA6-6732-4C1D-92D6-9083F4DB2E0F}"/>
              </a:ext>
            </a:extLst>
          </p:cNvPr>
          <p:cNvSpPr txBox="1"/>
          <p:nvPr/>
        </p:nvSpPr>
        <p:spPr>
          <a:xfrm>
            <a:off x="-129002" y="3572587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xmlns="" id="{5C48185D-A4EF-48BB-B972-3AC1E28ED522}"/>
              </a:ext>
            </a:extLst>
          </p:cNvPr>
          <p:cNvSpPr txBox="1"/>
          <p:nvPr/>
        </p:nvSpPr>
        <p:spPr>
          <a:xfrm>
            <a:off x="-129002" y="409640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xmlns="" id="{FC7E10CC-4695-4195-B339-A744FCA7BF9C}"/>
              </a:ext>
            </a:extLst>
          </p:cNvPr>
          <p:cNvSpPr txBox="1"/>
          <p:nvPr/>
        </p:nvSpPr>
        <p:spPr>
          <a:xfrm>
            <a:off x="-129002" y="4610698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xmlns="" id="{36E35497-C38A-4EB8-B445-C1E7A65AEDAD}"/>
              </a:ext>
            </a:extLst>
          </p:cNvPr>
          <p:cNvSpPr txBox="1"/>
          <p:nvPr/>
        </p:nvSpPr>
        <p:spPr>
          <a:xfrm>
            <a:off x="-129002" y="5131341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xmlns="" id="{5342DC3B-28A2-4D76-A37F-6FE1BB708FAE}"/>
              </a:ext>
            </a:extLst>
          </p:cNvPr>
          <p:cNvSpPr txBox="1"/>
          <p:nvPr/>
        </p:nvSpPr>
        <p:spPr>
          <a:xfrm>
            <a:off x="5980929" y="988221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A168601C-C0AA-47F7-A1D8-76E0BB36B396}"/>
              </a:ext>
            </a:extLst>
          </p:cNvPr>
          <p:cNvSpPr txBox="1"/>
          <p:nvPr/>
        </p:nvSpPr>
        <p:spPr>
          <a:xfrm>
            <a:off x="5980929" y="150251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E4C4861C-796C-458A-9467-7350F4D5D63C}"/>
              </a:ext>
            </a:extLst>
          </p:cNvPr>
          <p:cNvSpPr txBox="1"/>
          <p:nvPr/>
        </p:nvSpPr>
        <p:spPr>
          <a:xfrm>
            <a:off x="5980929" y="2026332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xmlns="" id="{852CCE2F-4BBD-498E-A633-93257C79E3A2}"/>
              </a:ext>
            </a:extLst>
          </p:cNvPr>
          <p:cNvSpPr txBox="1"/>
          <p:nvPr/>
        </p:nvSpPr>
        <p:spPr>
          <a:xfrm>
            <a:off x="5980929" y="254062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xmlns="" id="{F7275B4A-EB14-4CB3-80C9-3CFE0C75182B}"/>
              </a:ext>
            </a:extLst>
          </p:cNvPr>
          <p:cNvSpPr txBox="1"/>
          <p:nvPr/>
        </p:nvSpPr>
        <p:spPr>
          <a:xfrm>
            <a:off x="5980929" y="3065440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xmlns="" id="{A49DE36A-3F8F-4033-A9B7-19AED97F859C}"/>
              </a:ext>
            </a:extLst>
          </p:cNvPr>
          <p:cNvSpPr txBox="1"/>
          <p:nvPr/>
        </p:nvSpPr>
        <p:spPr>
          <a:xfrm>
            <a:off x="5980929" y="3579733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xmlns="" id="{7CDBBCD7-DF52-484E-A73B-B37D2B47A011}"/>
              </a:ext>
            </a:extLst>
          </p:cNvPr>
          <p:cNvSpPr txBox="1"/>
          <p:nvPr/>
        </p:nvSpPr>
        <p:spPr>
          <a:xfrm>
            <a:off x="5980929" y="4103551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xmlns="" id="{5C387B35-2615-4080-B86D-1414AAA9DF16}"/>
              </a:ext>
            </a:extLst>
          </p:cNvPr>
          <p:cNvSpPr txBox="1"/>
          <p:nvPr/>
        </p:nvSpPr>
        <p:spPr>
          <a:xfrm>
            <a:off x="5980929" y="461784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xmlns="" id="{3B7EC26E-A454-47A7-82A9-1029AACE40EC}"/>
              </a:ext>
            </a:extLst>
          </p:cNvPr>
          <p:cNvSpPr txBox="1"/>
          <p:nvPr/>
        </p:nvSpPr>
        <p:spPr>
          <a:xfrm>
            <a:off x="5980929" y="5138487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</p:spTree>
    <p:extLst>
      <p:ext uri="{BB962C8B-B14F-4D97-AF65-F5344CB8AC3E}">
        <p14:creationId xmlns:p14="http://schemas.microsoft.com/office/powerpoint/2010/main" val="19595098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0782547D-BE71-455B-A57D-65173D405F1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47"/>
          <a:stretch/>
        </p:blipFill>
        <p:spPr>
          <a:xfrm>
            <a:off x="6344522" y="981075"/>
            <a:ext cx="5821609" cy="456404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8F4BFB9D-EED6-4099-B0B1-25FC298FF29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24"/>
          <a:stretch/>
        </p:blipFill>
        <p:spPr>
          <a:xfrm>
            <a:off x="209425" y="957669"/>
            <a:ext cx="5894154" cy="4595241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80945E22-6392-4730-A204-F50A5F28705B}"/>
              </a:ext>
            </a:extLst>
          </p:cNvPr>
          <p:cNvSpPr txBox="1"/>
          <p:nvPr/>
        </p:nvSpPr>
        <p:spPr>
          <a:xfrm>
            <a:off x="-129002" y="98107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9" name="Título 1">
            <a:extLst>
              <a:ext uri="{FF2B5EF4-FFF2-40B4-BE49-F238E27FC236}">
                <a16:creationId xmlns:a16="http://schemas.microsoft.com/office/drawing/2014/main" xmlns="" id="{417A635D-E99E-48B4-ACD1-6F127FB93C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917" y="375443"/>
            <a:ext cx="10515600" cy="274955"/>
          </a:xfrm>
        </p:spPr>
        <p:txBody>
          <a:bodyPr>
            <a:noAutofit/>
          </a:bodyPr>
          <a:lstStyle/>
          <a:p>
            <a:pPr algn="ctr"/>
            <a:r>
              <a:rPr lang="en-US" sz="2000" b="1" i="1" dirty="0" smtClean="0"/>
              <a:t>B117Chr04_g003660</a:t>
            </a:r>
            <a:endParaRPr lang="en-US" sz="2000" b="1" i="1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B060A5CF-ACBE-4F33-B08C-D917A5B07148}"/>
              </a:ext>
            </a:extLst>
          </p:cNvPr>
          <p:cNvSpPr txBox="1"/>
          <p:nvPr/>
        </p:nvSpPr>
        <p:spPr>
          <a:xfrm>
            <a:off x="-129002" y="1495368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7AE839CB-116A-46CD-81D4-650762C404A9}"/>
              </a:ext>
            </a:extLst>
          </p:cNvPr>
          <p:cNvSpPr txBox="1"/>
          <p:nvPr/>
        </p:nvSpPr>
        <p:spPr>
          <a:xfrm>
            <a:off x="-129002" y="2019186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xmlns="" id="{0F41E53E-F993-4033-A0F5-94FBAE5D4E95}"/>
              </a:ext>
            </a:extLst>
          </p:cNvPr>
          <p:cNvSpPr txBox="1"/>
          <p:nvPr/>
        </p:nvSpPr>
        <p:spPr>
          <a:xfrm>
            <a:off x="-129002" y="2533479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5EBFCA43-96D9-43AC-A6AE-4CD8FCD5B7A1}"/>
              </a:ext>
            </a:extLst>
          </p:cNvPr>
          <p:cNvSpPr txBox="1"/>
          <p:nvPr/>
        </p:nvSpPr>
        <p:spPr>
          <a:xfrm>
            <a:off x="-129002" y="305829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46863CA6-6732-4C1D-92D6-9083F4DB2E0F}"/>
              </a:ext>
            </a:extLst>
          </p:cNvPr>
          <p:cNvSpPr txBox="1"/>
          <p:nvPr/>
        </p:nvSpPr>
        <p:spPr>
          <a:xfrm>
            <a:off x="-129002" y="3572587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xmlns="" id="{5C48185D-A4EF-48BB-B972-3AC1E28ED522}"/>
              </a:ext>
            </a:extLst>
          </p:cNvPr>
          <p:cNvSpPr txBox="1"/>
          <p:nvPr/>
        </p:nvSpPr>
        <p:spPr>
          <a:xfrm>
            <a:off x="-129002" y="409640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xmlns="" id="{FC7E10CC-4695-4195-B339-A744FCA7BF9C}"/>
              </a:ext>
            </a:extLst>
          </p:cNvPr>
          <p:cNvSpPr txBox="1"/>
          <p:nvPr/>
        </p:nvSpPr>
        <p:spPr>
          <a:xfrm>
            <a:off x="-129002" y="4610698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xmlns="" id="{36E35497-C38A-4EB8-B445-C1E7A65AEDAD}"/>
              </a:ext>
            </a:extLst>
          </p:cNvPr>
          <p:cNvSpPr txBox="1"/>
          <p:nvPr/>
        </p:nvSpPr>
        <p:spPr>
          <a:xfrm>
            <a:off x="-129002" y="5131341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xmlns="" id="{5342DC3B-28A2-4D76-A37F-6FE1BB708FAE}"/>
              </a:ext>
            </a:extLst>
          </p:cNvPr>
          <p:cNvSpPr txBox="1"/>
          <p:nvPr/>
        </p:nvSpPr>
        <p:spPr>
          <a:xfrm>
            <a:off x="5980929" y="988221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A168601C-C0AA-47F7-A1D8-76E0BB36B396}"/>
              </a:ext>
            </a:extLst>
          </p:cNvPr>
          <p:cNvSpPr txBox="1"/>
          <p:nvPr/>
        </p:nvSpPr>
        <p:spPr>
          <a:xfrm>
            <a:off x="5980929" y="150251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E4C4861C-796C-458A-9467-7350F4D5D63C}"/>
              </a:ext>
            </a:extLst>
          </p:cNvPr>
          <p:cNvSpPr txBox="1"/>
          <p:nvPr/>
        </p:nvSpPr>
        <p:spPr>
          <a:xfrm>
            <a:off x="5980929" y="2026332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xmlns="" id="{852CCE2F-4BBD-498E-A633-93257C79E3A2}"/>
              </a:ext>
            </a:extLst>
          </p:cNvPr>
          <p:cNvSpPr txBox="1"/>
          <p:nvPr/>
        </p:nvSpPr>
        <p:spPr>
          <a:xfrm>
            <a:off x="5980929" y="2540625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xmlns="" id="{F7275B4A-EB14-4CB3-80C9-3CFE0C75182B}"/>
              </a:ext>
            </a:extLst>
          </p:cNvPr>
          <p:cNvSpPr txBox="1"/>
          <p:nvPr/>
        </p:nvSpPr>
        <p:spPr>
          <a:xfrm>
            <a:off x="5980929" y="3065440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xmlns="" id="{A49DE36A-3F8F-4033-A9B7-19AED97F859C}"/>
              </a:ext>
            </a:extLst>
          </p:cNvPr>
          <p:cNvSpPr txBox="1"/>
          <p:nvPr/>
        </p:nvSpPr>
        <p:spPr>
          <a:xfrm>
            <a:off x="5980929" y="3579733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xmlns="" id="{7CDBBCD7-DF52-484E-A73B-B37D2B47A011}"/>
              </a:ext>
            </a:extLst>
          </p:cNvPr>
          <p:cNvSpPr txBox="1"/>
          <p:nvPr/>
        </p:nvSpPr>
        <p:spPr>
          <a:xfrm>
            <a:off x="5980929" y="4103551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xmlns="" id="{5C387B35-2615-4080-B86D-1414AAA9DF16}"/>
              </a:ext>
            </a:extLst>
          </p:cNvPr>
          <p:cNvSpPr txBox="1"/>
          <p:nvPr/>
        </p:nvSpPr>
        <p:spPr>
          <a:xfrm>
            <a:off x="5980929" y="4617844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xmlns="" id="{3B7EC26E-A454-47A7-82A9-1029AACE40EC}"/>
              </a:ext>
            </a:extLst>
          </p:cNvPr>
          <p:cNvSpPr txBox="1"/>
          <p:nvPr/>
        </p:nvSpPr>
        <p:spPr>
          <a:xfrm>
            <a:off x="5980929" y="5138487"/>
            <a:ext cx="4307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00" dirty="0"/>
              <a:t>Consensus</a:t>
            </a:r>
          </a:p>
          <a:p>
            <a:pPr algn="r"/>
            <a:r>
              <a:rPr lang="en-US" sz="300" dirty="0"/>
              <a:t>Reference</a:t>
            </a:r>
          </a:p>
          <a:p>
            <a:pPr algn="r"/>
            <a:r>
              <a:rPr lang="en-US" sz="300" dirty="0"/>
              <a:t>Cloned cDNA</a:t>
            </a:r>
          </a:p>
        </p:txBody>
      </p:sp>
    </p:spTree>
    <p:extLst>
      <p:ext uri="{BB962C8B-B14F-4D97-AF65-F5344CB8AC3E}">
        <p14:creationId xmlns:p14="http://schemas.microsoft.com/office/powerpoint/2010/main" val="37732690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Wisp</Template>
  <TotalTime>864</TotalTime>
  <Words>389</Words>
  <Application>Microsoft Office PowerPoint</Application>
  <PresentationFormat>Personalizado</PresentationFormat>
  <Paragraphs>235</Paragraphs>
  <Slides>6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7" baseType="lpstr">
      <vt:lpstr>Tema de Office</vt:lpstr>
      <vt:lpstr>Presentación de PowerPoint</vt:lpstr>
      <vt:lpstr>Presentación de PowerPoint</vt:lpstr>
      <vt:lpstr>HannDeb2Chr04g005720 (RLK-2)</vt:lpstr>
      <vt:lpstr>HannDeb2Chr04g005880 (RLK-4)</vt:lpstr>
      <vt:lpstr>B117Chr04_g003667</vt:lpstr>
      <vt:lpstr>B117Chr04_g003660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DNA sequences completed</dc:title>
  <dc:creator>Belen Fernandez</dc:creator>
  <cp:lastModifiedBy>Bego</cp:lastModifiedBy>
  <cp:revision>38</cp:revision>
  <dcterms:created xsi:type="dcterms:W3CDTF">2023-08-14T09:57:03Z</dcterms:created>
  <dcterms:modified xsi:type="dcterms:W3CDTF">2026-02-11T17:28:26Z</dcterms:modified>
</cp:coreProperties>
</file>